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F2D49-504F-4F15-A5E7-B236CC3828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6FBBD-B0AD-44F7-85A4-B4F6BE6F3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2219D-4596-47A7-9A88-BBCDD71B16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6EE7A-D527-4A20-A047-E6BB45B183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93191-4BA5-433E-95E4-CC387E7502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0A7A0-548B-4AF6-993F-265DD15223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0423B-D991-4EFD-9F75-FC615BB0DA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8E130-6D47-45CA-954E-80AACDC988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C29B7-499F-47AD-842D-58F0C8A500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890E5-00D9-4F72-B83C-34AADDF9F9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51D1C-746F-426C-968E-87AE8A4CD4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1ACD1-FDC0-4B2C-883A-0D8C138C7E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0DB052-ADD7-4EEF-BED0-08E2D1281CDE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836640" y="2538360"/>
            <a:ext cx="5172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1. Normalization of small RNA Libraries using Bowtie (Langmead et.al, 2009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79600" y="3235320"/>
          <a:ext cx="3618000" cy="3417840"/>
        </p:xfrm>
        <a:graphic>
          <a:graphicData uri="http://schemas.openxmlformats.org/drawingml/2006/table">
            <a:tbl>
              <a:tblPr/>
              <a:tblGrid>
                <a:gridCol w="1766880"/>
                <a:gridCol w="971640"/>
                <a:gridCol w="879480"/>
              </a:tblGrid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 reads (after clippin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842.1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406.1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liminated reads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23.8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3.0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iltered small RNA rea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618.3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803.1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pped rea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973.4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884.1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iallele small RNAs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</a:tr>
              <a:tr h="244080">
                <a:tc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rmalization factor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,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8400">
                <a:tc>
                  <a:txBody>
                    <a:bodyPr lIns="90000" rIns="900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96360">
                <a:tc gridSpan="3"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 rRNA, tRNA, snRNA, snoRNA, mitochondrial RNA, chloroplast R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8640">
                <a:tc gridSpan="3"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* reads homologous to the transgenic epiallele are not present in the TAIR Arabidopsis sequence and are not included in the mapped rea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4080">
                <a:tc gridSpan="3">
                  <a:txBody>
                    <a:bodyPr lIns="90000" rIns="900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** per 1 million small RNA rea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3" name="Text Box 504"/>
          <p:cNvSpPr/>
          <p:nvPr/>
        </p:nvSpPr>
        <p:spPr>
          <a:xfrm>
            <a:off x="2591640" y="16992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oerster et al., Table 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6T09:07:43Z</dcterms:created>
  <dc:creator>Andrea</dc:creator>
  <dc:description/>
  <dc:language>en-US</dc:language>
  <cp:lastModifiedBy>Mittelsten Scheid, Ortrun</cp:lastModifiedBy>
  <dcterms:modified xsi:type="dcterms:W3CDTF">2011-08-31T09:29:10Z</dcterms:modified>
  <cp:revision>112</cp:revision>
  <dc:subject/>
  <dc:title>Slide 1</dc:title>
</cp:coreProperties>
</file>